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48" d="100"/>
          <a:sy n="148" d="100"/>
        </p:scale>
        <p:origin x="2154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12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12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136317" y="5602896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Herder and Roden (2022) Diabetologia DOI 10.1007/s00125-021-05625-x </a:t>
            </a:r>
          </a:p>
          <a:p>
            <a:r>
              <a:rPr lang="en-GB" sz="1200" dirty="0"/>
              <a:t>© 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82087" y="468993"/>
            <a:ext cx="695420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ssible future implications of precision diabetology based on the novel diabetes subgroup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3A12A52-67D9-4BE0-A416-00A74B3EDC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48265" y="372290"/>
            <a:ext cx="1899514" cy="85916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4A21B0D-2633-4245-8EDA-E96AC1129FE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5242" y="1231435"/>
            <a:ext cx="6659594" cy="45738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</TotalTime>
  <Words>53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41</cp:revision>
  <dcterms:created xsi:type="dcterms:W3CDTF">2016-06-15T12:53:43Z</dcterms:created>
  <dcterms:modified xsi:type="dcterms:W3CDTF">2021-12-07T10:09:05Z</dcterms:modified>
</cp:coreProperties>
</file>